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152" y="35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BC956-94E3-4110-8DA8-6AC258700E58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4BBD5-CEA2-478C-9E04-CDA27CCE6E03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30253225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BC956-94E3-4110-8DA8-6AC258700E58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4BBD5-CEA2-478C-9E04-CDA27CCE6E03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4134093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BC956-94E3-4110-8DA8-6AC258700E58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4BBD5-CEA2-478C-9E04-CDA27CCE6E03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2893246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BC956-94E3-4110-8DA8-6AC258700E58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4BBD5-CEA2-478C-9E04-CDA27CCE6E03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64020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BC956-94E3-4110-8DA8-6AC258700E58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4BBD5-CEA2-478C-9E04-CDA27CCE6E03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2440952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BC956-94E3-4110-8DA8-6AC258700E58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4BBD5-CEA2-478C-9E04-CDA27CCE6E03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21831825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BC956-94E3-4110-8DA8-6AC258700E58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4BBD5-CEA2-478C-9E04-CDA27CCE6E03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3308002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BC956-94E3-4110-8DA8-6AC258700E58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4BBD5-CEA2-478C-9E04-CDA27CCE6E03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3743270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BC956-94E3-4110-8DA8-6AC258700E58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4BBD5-CEA2-478C-9E04-CDA27CCE6E03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1694707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BC956-94E3-4110-8DA8-6AC258700E58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4BBD5-CEA2-478C-9E04-CDA27CCE6E03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2991474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BC956-94E3-4110-8DA8-6AC258700E58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E4BBD5-CEA2-478C-9E04-CDA27CCE6E03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41318437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6BC956-94E3-4110-8DA8-6AC258700E58}" type="datetimeFigureOut">
              <a:rPr lang="nl-NL" smtClean="0"/>
              <a:pPr/>
              <a:t>27-4-2016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E4BBD5-CEA2-478C-9E04-CDA27CCE6E03}" type="slidenum">
              <a:rPr lang="nl-NL" smtClean="0"/>
              <a:pPr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xmlns="" val="21563161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59440" y="76470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A</a:t>
            </a:r>
            <a:endParaRPr lang="en-GB" b="1" dirty="0"/>
          </a:p>
        </p:txBody>
      </p:sp>
      <p:sp>
        <p:nvSpPr>
          <p:cNvPr id="5" name="TextBox 4"/>
          <p:cNvSpPr txBox="1"/>
          <p:nvPr/>
        </p:nvSpPr>
        <p:spPr>
          <a:xfrm>
            <a:off x="365852" y="378904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B</a:t>
            </a:r>
            <a:endParaRPr lang="en-GB" b="1" dirty="0"/>
          </a:p>
        </p:txBody>
      </p:sp>
      <p:pic>
        <p:nvPicPr>
          <p:cNvPr id="7" name="Picture 3" descr="E:\argB,nicB,adeA\Picture9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481579" y="3933056"/>
            <a:ext cx="4428413" cy="27150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7668344" y="332656"/>
            <a:ext cx="1204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. Fig 2</a:t>
            </a:r>
            <a:endParaRPr lang="en-GB" dirty="0"/>
          </a:p>
        </p:txBody>
      </p:sp>
      <p:pic>
        <p:nvPicPr>
          <p:cNvPr id="8" name="Picture 7" descr="E:\argB,nicB,adeA\adeA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475656" y="836712"/>
            <a:ext cx="4891480" cy="2667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Rectangle 9"/>
          <p:cNvSpPr/>
          <p:nvPr/>
        </p:nvSpPr>
        <p:spPr>
          <a:xfrm>
            <a:off x="5724128" y="5085184"/>
            <a:ext cx="3419872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article </a:t>
            </a:r>
            <a:r>
              <a:rPr lang="en-GB" sz="1000" b="1" dirty="0" smtClean="0">
                <a:latin typeface="Arial" pitchFamily="34" charset="0"/>
                <a:cs typeface="Arial" pitchFamily="34" charset="0"/>
              </a:rPr>
              <a:t>title: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A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set of isogenic auxotrophic strains for constructing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multiple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gene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deletion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mutants and parasexual crossings in Aspergillus niger</a:t>
            </a:r>
          </a:p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000" b="1" dirty="0" smtClean="0">
                <a:latin typeface="Arial" pitchFamily="34" charset="0"/>
                <a:cs typeface="Arial" pitchFamily="34" charset="0"/>
              </a:rPr>
              <a:t>journal name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Archives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of Microbiology</a:t>
            </a:r>
          </a:p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author </a:t>
            </a:r>
            <a:r>
              <a:rPr lang="en-GB" sz="1000" b="1" dirty="0" smtClean="0">
                <a:latin typeface="Arial" pitchFamily="34" charset="0"/>
                <a:cs typeface="Arial" pitchFamily="34" charset="0"/>
              </a:rPr>
              <a:t>names: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Jing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Niu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Mark Arentshorst, Felix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Seelinger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, Arthur F.J. Ram*,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Jean Paul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Ouedraogo</a:t>
            </a:r>
          </a:p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affiliation: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Molecular Microbiology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and Biotechnology, Leiden University, 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Sylviusweg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72, 2333 BE Leiden, the Netherlands</a:t>
            </a:r>
          </a:p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corresponding author</a:t>
            </a:r>
            <a:r>
              <a:rPr lang="en-GB" sz="1000" b="1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a.f.j.ram@biology.leidenuniv.nl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207508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</TotalTime>
  <Words>77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eit Leide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m, A.F.J.</dc:creator>
  <cp:lastModifiedBy>Arthur Ram</cp:lastModifiedBy>
  <cp:revision>5</cp:revision>
  <dcterms:created xsi:type="dcterms:W3CDTF">2016-03-10T13:26:03Z</dcterms:created>
  <dcterms:modified xsi:type="dcterms:W3CDTF">2016-04-27T10:56:55Z</dcterms:modified>
</cp:coreProperties>
</file>